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00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3" autoAdjust="0"/>
    <p:restoredTop sz="94660"/>
  </p:normalViewPr>
  <p:slideViewPr>
    <p:cSldViewPr snapToGrid="0">
      <p:cViewPr>
        <p:scale>
          <a:sx n="58" d="100"/>
          <a:sy n="58" d="100"/>
        </p:scale>
        <p:origin x="-2136" y="-24"/>
      </p:cViewPr>
      <p:guideLst>
        <p:guide orient="horz" pos="200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12281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36896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50601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58440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26819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74345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07290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42848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61977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67027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27029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85324-5385-4082-BAEA-7E7817602D1A}" type="datetimeFigureOut">
              <a:rPr lang="nl-NL" smtClean="0"/>
              <a:t>7-11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14D7F-3F9F-4AF4-A7E4-02028335F0B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42354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hoek 1"/>
          <p:cNvSpPr/>
          <p:nvPr/>
        </p:nvSpPr>
        <p:spPr>
          <a:xfrm>
            <a:off x="265474" y="127497"/>
            <a:ext cx="21537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/>
              <a:t>Figure S1 Coene et al</a:t>
            </a:r>
          </a:p>
        </p:txBody>
      </p:sp>
      <p:sp>
        <p:nvSpPr>
          <p:cNvPr id="7" name="Tekstvak 6"/>
          <p:cNvSpPr txBox="1"/>
          <p:nvPr/>
        </p:nvSpPr>
        <p:spPr>
          <a:xfrm>
            <a:off x="288760" y="708741"/>
            <a:ext cx="5534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/>
              <a:t>A</a:t>
            </a:r>
          </a:p>
        </p:txBody>
      </p:sp>
      <p:sp>
        <p:nvSpPr>
          <p:cNvPr id="8" name="Tekstvak 7"/>
          <p:cNvSpPr txBox="1"/>
          <p:nvPr/>
        </p:nvSpPr>
        <p:spPr>
          <a:xfrm>
            <a:off x="3200209" y="708740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400"/>
              <a:t>B</a:t>
            </a:r>
          </a:p>
        </p:txBody>
      </p:sp>
      <p:sp>
        <p:nvSpPr>
          <p:cNvPr id="9" name="Tekstvak 8"/>
          <p:cNvSpPr txBox="1"/>
          <p:nvPr/>
        </p:nvSpPr>
        <p:spPr>
          <a:xfrm>
            <a:off x="288760" y="2512141"/>
            <a:ext cx="5534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/>
              <a:t>C</a:t>
            </a:r>
          </a:p>
        </p:txBody>
      </p:sp>
      <p:sp>
        <p:nvSpPr>
          <p:cNvPr id="10" name="Tekstvak 9"/>
          <p:cNvSpPr txBox="1"/>
          <p:nvPr/>
        </p:nvSpPr>
        <p:spPr>
          <a:xfrm>
            <a:off x="3200209" y="2512140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400"/>
              <a:t>D</a:t>
            </a:r>
          </a:p>
        </p:txBody>
      </p:sp>
      <p:sp>
        <p:nvSpPr>
          <p:cNvPr id="11" name="Tekstvak 10"/>
          <p:cNvSpPr txBox="1"/>
          <p:nvPr/>
        </p:nvSpPr>
        <p:spPr>
          <a:xfrm>
            <a:off x="288760" y="4535680"/>
            <a:ext cx="5534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/>
              <a:t>E</a:t>
            </a:r>
          </a:p>
        </p:txBody>
      </p:sp>
      <p:sp>
        <p:nvSpPr>
          <p:cNvPr id="12" name="Tekstvak 11"/>
          <p:cNvSpPr txBox="1"/>
          <p:nvPr/>
        </p:nvSpPr>
        <p:spPr>
          <a:xfrm>
            <a:off x="3200209" y="4535679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400"/>
              <a:t>F</a:t>
            </a:r>
          </a:p>
        </p:txBody>
      </p:sp>
      <p:sp>
        <p:nvSpPr>
          <p:cNvPr id="13" name="Tekstvak 12"/>
          <p:cNvSpPr txBox="1"/>
          <p:nvPr/>
        </p:nvSpPr>
        <p:spPr>
          <a:xfrm>
            <a:off x="231683" y="6600550"/>
            <a:ext cx="5534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/>
              <a:t>G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1630851"/>
              </p:ext>
            </p:extLst>
          </p:nvPr>
        </p:nvGraphicFramePr>
        <p:xfrm>
          <a:off x="380028" y="862628"/>
          <a:ext cx="2401313" cy="1745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55" name="Prism 8" r:id="rId3" imgW="4002188" imgH="2908964" progId="Prism8.Document">
                  <p:embed/>
                </p:oleObj>
              </mc:Choice>
              <mc:Fallback>
                <p:oleObj name="Prism 8" r:id="rId3" imgW="4002188" imgH="290896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0028" y="862628"/>
                        <a:ext cx="2401313" cy="1745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7004645"/>
              </p:ext>
            </p:extLst>
          </p:nvPr>
        </p:nvGraphicFramePr>
        <p:xfrm>
          <a:off x="3495483" y="862628"/>
          <a:ext cx="2401313" cy="1745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56" name="Prism 8" r:id="rId5" imgW="4002188" imgH="2908964" progId="Prism8.Document">
                  <p:embed/>
                </p:oleObj>
              </mc:Choice>
              <mc:Fallback>
                <p:oleObj name="Prism 8" r:id="rId5" imgW="4002188" imgH="290896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95483" y="862628"/>
                        <a:ext cx="2401313" cy="1745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1664266"/>
              </p:ext>
            </p:extLst>
          </p:nvPr>
        </p:nvGraphicFramePr>
        <p:xfrm>
          <a:off x="380028" y="2831633"/>
          <a:ext cx="2401313" cy="1745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57" name="Prism 8" r:id="rId7" imgW="4002188" imgH="2908964" progId="Prism8.Document">
                  <p:embed/>
                </p:oleObj>
              </mc:Choice>
              <mc:Fallback>
                <p:oleObj name="Prism 8" r:id="rId7" imgW="4002188" imgH="290896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0028" y="2831633"/>
                        <a:ext cx="2401313" cy="1745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5339828"/>
              </p:ext>
            </p:extLst>
          </p:nvPr>
        </p:nvGraphicFramePr>
        <p:xfrm>
          <a:off x="3495483" y="2831633"/>
          <a:ext cx="2401313" cy="1745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58" name="Prism 8" r:id="rId9" imgW="4002188" imgH="2908964" progId="Prism8.Document">
                  <p:embed/>
                </p:oleObj>
              </mc:Choice>
              <mc:Fallback>
                <p:oleObj name="Prism 8" r:id="rId9" imgW="4002188" imgH="290896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495483" y="2831633"/>
                        <a:ext cx="2401313" cy="1745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7944151"/>
              </p:ext>
            </p:extLst>
          </p:nvPr>
        </p:nvGraphicFramePr>
        <p:xfrm>
          <a:off x="401960" y="4843456"/>
          <a:ext cx="2401313" cy="1745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59" name="Prism 8" r:id="rId11" imgW="4002188" imgH="2908964" progId="Prism8.Document">
                  <p:embed/>
                </p:oleObj>
              </mc:Choice>
              <mc:Fallback>
                <p:oleObj name="Prism 8" r:id="rId11" imgW="4002188" imgH="290896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01960" y="4843456"/>
                        <a:ext cx="2401313" cy="1745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6134195"/>
              </p:ext>
            </p:extLst>
          </p:nvPr>
        </p:nvGraphicFramePr>
        <p:xfrm>
          <a:off x="3495483" y="4800638"/>
          <a:ext cx="2401313" cy="1745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60" name="Prism 8" r:id="rId13" imgW="4002188" imgH="2908964" progId="Prism8.Document">
                  <p:embed/>
                </p:oleObj>
              </mc:Choice>
              <mc:Fallback>
                <p:oleObj name="Prism 8" r:id="rId13" imgW="4002188" imgH="290896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495483" y="4800638"/>
                        <a:ext cx="2401313" cy="1745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2155792"/>
              </p:ext>
            </p:extLst>
          </p:nvPr>
        </p:nvGraphicFramePr>
        <p:xfrm>
          <a:off x="401960" y="6908327"/>
          <a:ext cx="2401313" cy="1745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61" name="Prism 8" r:id="rId15" imgW="4002188" imgH="2908964" progId="Prism8.Document">
                  <p:embed/>
                </p:oleObj>
              </mc:Choice>
              <mc:Fallback>
                <p:oleObj name="Prism 8" r:id="rId15" imgW="4002188" imgH="290896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01960" y="6908327"/>
                        <a:ext cx="2401313" cy="1745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Tabel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5732102"/>
              </p:ext>
            </p:extLst>
          </p:nvPr>
        </p:nvGraphicFramePr>
        <p:xfrm>
          <a:off x="3642850" y="6940393"/>
          <a:ext cx="2690956" cy="1463040"/>
        </p:xfrm>
        <a:graphic>
          <a:graphicData uri="http://schemas.openxmlformats.org/drawingml/2006/table">
            <a:tbl>
              <a:tblPr firstRow="1" firstCol="1" bandRow="1"/>
              <a:tblGrid>
                <a:gridCol w="744796">
                  <a:extLst>
                    <a:ext uri="{9D8B030D-6E8A-4147-A177-3AD203B41FA5}">
                      <a16:colId xmlns:a16="http://schemas.microsoft.com/office/drawing/2014/main" xmlns="" val="1102327510"/>
                    </a:ext>
                  </a:extLst>
                </a:gridCol>
                <a:gridCol w="862780">
                  <a:extLst>
                    <a:ext uri="{9D8B030D-6E8A-4147-A177-3AD203B41FA5}">
                      <a16:colId xmlns:a16="http://schemas.microsoft.com/office/drawing/2014/main" xmlns="" val="2696727738"/>
                    </a:ext>
                  </a:extLst>
                </a:gridCol>
                <a:gridCol w="1083380">
                  <a:extLst>
                    <a:ext uri="{9D8B030D-6E8A-4147-A177-3AD203B41FA5}">
                      <a16:colId xmlns:a16="http://schemas.microsoft.com/office/drawing/2014/main" xmlns="" val="4069939652"/>
                    </a:ext>
                  </a:extLst>
                </a:gridCol>
              </a:tblGrid>
              <a:tr h="175369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ab</a:t>
                      </a:r>
                      <a:endParaRPr lang="nl-NL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CI slope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CI Y-intercept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26637639"/>
                  </a:ext>
                </a:extLst>
              </a:tr>
              <a:tr h="175369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 to 1.4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83.3 to -38.9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59933007"/>
                  </a:ext>
                </a:extLst>
              </a:tr>
              <a:tr h="175369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 to 1.1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13.6 to 188.7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03879367"/>
                  </a:ext>
                </a:extLst>
              </a:tr>
              <a:tr h="175369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 to 0.8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8.4 to 40.4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25959591"/>
                  </a:ext>
                </a:extLst>
              </a:tr>
              <a:tr h="175369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 to 1.4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94.1 to 148.1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92101483"/>
                  </a:ext>
                </a:extLst>
              </a:tr>
              <a:tr h="175369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1 to 1.5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79.2 to 10.9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17724494"/>
                  </a:ext>
                </a:extLst>
              </a:tr>
              <a:tr h="175369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 to 1.0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72.3 to 9.9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5499037"/>
                  </a:ext>
                </a:extLst>
              </a:tr>
              <a:tr h="175369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 to 1.1</a:t>
                      </a:r>
                      <a:endParaRPr lang="nl-NL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 to 119.9</a:t>
                      </a:r>
                      <a:endParaRPr lang="nl-NL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2611" marR="5261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1050566"/>
                  </a:ext>
                </a:extLst>
              </a:tr>
            </a:tbl>
          </a:graphicData>
        </a:graphic>
      </p:graphicFrame>
      <p:sp>
        <p:nvSpPr>
          <p:cNvPr id="19" name="Tekstvak 18"/>
          <p:cNvSpPr txBox="1"/>
          <p:nvPr/>
        </p:nvSpPr>
        <p:spPr>
          <a:xfrm>
            <a:off x="3205933" y="6632616"/>
            <a:ext cx="5534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947826878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6</TotalTime>
  <Words>78</Words>
  <Application>Microsoft Office PowerPoint</Application>
  <PresentationFormat>A4 Paper (210x297 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Kantoorthema</vt:lpstr>
      <vt:lpstr>Prism 8</vt:lpstr>
      <vt:lpstr>PowerPoint Presentation</vt:lpstr>
    </vt:vector>
  </TitlesOfParts>
  <Company>A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Susan Goorden</dc:creator>
  <cp:lastModifiedBy>303444</cp:lastModifiedBy>
  <cp:revision>60</cp:revision>
  <cp:lastPrinted>2019-08-12T11:23:49Z</cp:lastPrinted>
  <dcterms:created xsi:type="dcterms:W3CDTF">2019-05-03T08:00:07Z</dcterms:created>
  <dcterms:modified xsi:type="dcterms:W3CDTF">2020-11-07T02:48:23Z</dcterms:modified>
</cp:coreProperties>
</file>